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5FF4F-C990-4BC1-8FFD-6254F2301A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AA8EA-E2B7-49ED-9554-3AE04DE412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BBA172-8205-4C38-9DB0-B9114535D5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88AB9-791A-4748-85E7-BB2F9E8B32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1B567-0343-47E9-8EC8-2A638B278B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2F7A4-F240-4507-97B4-1CF8776150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E94E6-63AA-4B33-BCC1-B102D923C2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2DB4B2-7E5C-4AB6-ADF7-61D52EA010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6360B-252F-4A0F-81A8-2B8891AD5B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83A5C-909B-4215-B47D-3764B001A9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3F3F8-2650-4081-B9CB-2C11651A49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3186C-EAD9-495B-ACE2-63DDF11A87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274F10-8F15-464E-9015-B0DE38CC0D0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4259" t="0" r="3297" b="0"/>
          <a:stretch/>
        </p:blipFill>
        <p:spPr>
          <a:xfrm>
            <a:off x="0" y="649440"/>
            <a:ext cx="6858000" cy="27064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4239" t="0" r="3317" b="0"/>
          <a:stretch/>
        </p:blipFill>
        <p:spPr>
          <a:xfrm>
            <a:off x="0" y="3524400"/>
            <a:ext cx="6858000" cy="270828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rcRect l="4259" t="0" r="3297" b="0"/>
          <a:stretch/>
        </p:blipFill>
        <p:spPr>
          <a:xfrm>
            <a:off x="0" y="6402240"/>
            <a:ext cx="6858000" cy="27068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440640" y="250920"/>
            <a:ext cx="59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Fig S1:Mismatch plots: deviant minus preceding standar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rcRect l="4947" t="0" r="6573" b="0"/>
          <a:stretch/>
        </p:blipFill>
        <p:spPr>
          <a:xfrm>
            <a:off x="0" y="861840"/>
            <a:ext cx="6697800" cy="272448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2"/>
          <a:srcRect l="5779" t="0" r="6573" b="0"/>
          <a:stretch/>
        </p:blipFill>
        <p:spPr>
          <a:xfrm>
            <a:off x="160200" y="6419880"/>
            <a:ext cx="6634440" cy="272412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427680" y="250920"/>
            <a:ext cx="600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Fig S2. Dummy plots: standard minus preceding standar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3"/>
          <a:srcRect l="7388" t="0" r="7405" b="0"/>
          <a:stretch/>
        </p:blipFill>
        <p:spPr>
          <a:xfrm>
            <a:off x="216000" y="3741840"/>
            <a:ext cx="6453000" cy="252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"/>
          <p:cNvGrpSpPr/>
          <p:nvPr/>
        </p:nvGrpSpPr>
        <p:grpSpPr>
          <a:xfrm>
            <a:off x="-125280" y="576360"/>
            <a:ext cx="6983280" cy="8459280"/>
            <a:chOff x="-125280" y="576360"/>
            <a:chExt cx="6983280" cy="8459280"/>
          </a:xfrm>
        </p:grpSpPr>
        <p:pic>
          <p:nvPicPr>
            <p:cNvPr id="50" name="" descr=""/>
            <p:cNvPicPr/>
            <p:nvPr/>
          </p:nvPicPr>
          <p:blipFill>
            <a:blip r:embed="rId1"/>
            <a:srcRect l="5779" t="0" r="6573" b="0"/>
            <a:stretch/>
          </p:blipFill>
          <p:spPr>
            <a:xfrm>
              <a:off x="-125280" y="576360"/>
              <a:ext cx="6983280" cy="2706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" descr=""/>
            <p:cNvPicPr/>
            <p:nvPr/>
          </p:nvPicPr>
          <p:blipFill>
            <a:blip r:embed="rId2"/>
            <a:srcRect l="5762" t="0" r="6594" b="0"/>
            <a:stretch/>
          </p:blipFill>
          <p:spPr>
            <a:xfrm>
              <a:off x="-125280" y="3451680"/>
              <a:ext cx="6983280" cy="2706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" descr=""/>
            <p:cNvPicPr/>
            <p:nvPr/>
          </p:nvPicPr>
          <p:blipFill>
            <a:blip r:embed="rId3"/>
            <a:srcRect l="5779" t="0" r="6573" b="0"/>
            <a:stretch/>
          </p:blipFill>
          <p:spPr>
            <a:xfrm>
              <a:off x="-125280" y="6329160"/>
              <a:ext cx="6983280" cy="27064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3" name=""/>
          <p:cNvSpPr/>
          <p:nvPr/>
        </p:nvSpPr>
        <p:spPr>
          <a:xfrm>
            <a:off x="2424240" y="250920"/>
            <a:ext cx="411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Fig S3: Mismatch response, even tria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"/>
          <p:cNvGrpSpPr/>
          <p:nvPr/>
        </p:nvGrpSpPr>
        <p:grpSpPr>
          <a:xfrm>
            <a:off x="-27000" y="611280"/>
            <a:ext cx="6912000" cy="8424360"/>
            <a:chOff x="-27000" y="611280"/>
            <a:chExt cx="6912000" cy="8424360"/>
          </a:xfrm>
        </p:grpSpPr>
        <p:pic>
          <p:nvPicPr>
            <p:cNvPr id="55" name="" descr=""/>
            <p:cNvPicPr/>
            <p:nvPr/>
          </p:nvPicPr>
          <p:blipFill>
            <a:blip r:embed="rId1"/>
            <a:srcRect l="6594" t="0" r="6573" b="0"/>
            <a:stretch/>
          </p:blipFill>
          <p:spPr>
            <a:xfrm>
              <a:off x="-27000" y="611280"/>
              <a:ext cx="6847920" cy="276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" descr=""/>
            <p:cNvPicPr/>
            <p:nvPr/>
          </p:nvPicPr>
          <p:blipFill>
            <a:blip r:embed="rId2"/>
            <a:srcRect l="6594" t="0" r="5762" b="0"/>
            <a:stretch/>
          </p:blipFill>
          <p:spPr>
            <a:xfrm>
              <a:off x="-27000" y="3464640"/>
              <a:ext cx="6912000" cy="276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" descr=""/>
            <p:cNvPicPr/>
            <p:nvPr/>
          </p:nvPicPr>
          <p:blipFill>
            <a:blip r:embed="rId3"/>
            <a:srcRect l="6594" t="0" r="5762" b="0"/>
            <a:stretch/>
          </p:blipFill>
          <p:spPr>
            <a:xfrm>
              <a:off x="-27000" y="6275160"/>
              <a:ext cx="6912000" cy="27604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8" name=""/>
          <p:cNvSpPr/>
          <p:nvPr/>
        </p:nvSpPr>
        <p:spPr>
          <a:xfrm>
            <a:off x="2279520" y="250920"/>
            <a:ext cx="405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Fig S4: Mismatch response, Odd tria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17T13:06:47Z</dcterms:created>
  <dc:creator>BISHOP</dc:creator>
  <dc:description/>
  <dc:language>en-US</dc:language>
  <cp:lastModifiedBy>BISHOP</cp:lastModifiedBy>
  <dcterms:modified xsi:type="dcterms:W3CDTF">2009-05-18T15:09:21Z</dcterms:modified>
  <cp:revision>9</cp:revision>
  <dc:subject/>
  <dc:title>Slide 1</dc:title>
</cp:coreProperties>
</file>